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  <p:sldId id="275" r:id="rId3"/>
    <p:sldId id="265" r:id="rId4"/>
    <p:sldId id="276" r:id="rId5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2" d="100"/>
          <a:sy n="82" d="100"/>
        </p:scale>
        <p:origin x="643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IBERS%20Work%20Desktop%20backup%2021-03-20\Miscanthus%20Cell%20Wall%20Deconstruction\Jan-Dec%202020\Oligosaccharide%20composition%20and%20yield%20produced%20after%20SE%20and%20C2mim%20pretreatment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Tabelle1!$B$4</c:f>
              <c:strCache>
                <c:ptCount val="1"/>
                <c:pt idx="0">
                  <c:v>Steam Explosion</c:v>
                </c:pt>
              </c:strCache>
            </c:strRef>
          </c:tx>
          <c:spPr>
            <a:solidFill>
              <a:schemeClr val="accent2"/>
            </a:solidFill>
            <a:ln>
              <a:solidFill>
                <a:schemeClr val="accent2"/>
              </a:solidFill>
            </a:ln>
            <a:effectLst/>
            <a:sp3d>
              <a:contourClr>
                <a:schemeClr val="accent2"/>
              </a:contourClr>
            </a:sp3d>
          </c:spPr>
          <c:invertIfNegative val="0"/>
          <c:dLbls>
            <c:numFmt formatCode="#,##0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Tabelle1!$F$6:$F$9</c:f>
              <c:strCache>
                <c:ptCount val="2"/>
                <c:pt idx="0">
                  <c:v>GOS</c:v>
                </c:pt>
                <c:pt idx="1">
                  <c:v>XOS</c:v>
                </c:pt>
              </c:strCache>
              <c:extLst/>
            </c:strRef>
          </c:cat>
          <c:val>
            <c:numRef>
              <c:f>Tabelle1!$C$6:$C$9</c:f>
              <c:numCache>
                <c:formatCode>#,#00</c:formatCode>
                <c:ptCount val="2"/>
                <c:pt idx="0">
                  <c:v>8.7497098487892622</c:v>
                </c:pt>
                <c:pt idx="1">
                  <c:v>51.620112103122395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0-48BE-420E-B360-C5837D4E3FEA}"/>
            </c:ext>
          </c:extLst>
        </c:ser>
        <c:ser>
          <c:idx val="1"/>
          <c:order val="1"/>
          <c:tx>
            <c:strRef>
              <c:f>Tabelle1!$F$4</c:f>
              <c:strCache>
                <c:ptCount val="1"/>
                <c:pt idx="0">
                  <c:v>[C2mim][OAc]</c:v>
                </c:pt>
              </c:strCache>
            </c:strRef>
          </c:tx>
          <c:spPr>
            <a:solidFill>
              <a:srgbClr val="0070C0"/>
            </a:solidFill>
            <a:ln>
              <a:solidFill>
                <a:schemeClr val="accent1"/>
              </a:solidFill>
            </a:ln>
            <a:effectLst/>
            <a:sp3d>
              <a:contourClr>
                <a:schemeClr val="accent1"/>
              </a:contourClr>
            </a:sp3d>
          </c:spPr>
          <c:invertIfNegative val="0"/>
          <c:dLbls>
            <c:numFmt formatCode="#,##0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Tabelle1!$F$6:$F$9</c:f>
              <c:strCache>
                <c:ptCount val="2"/>
                <c:pt idx="0">
                  <c:v>GOS</c:v>
                </c:pt>
                <c:pt idx="1">
                  <c:v>XOS</c:v>
                </c:pt>
              </c:strCache>
              <c:extLst/>
            </c:strRef>
          </c:cat>
          <c:val>
            <c:numRef>
              <c:f>Tabelle1!$G$6:$G$9</c:f>
              <c:numCache>
                <c:formatCode>#,#00</c:formatCode>
                <c:ptCount val="2"/>
                <c:pt idx="0">
                  <c:v>4.9714235171598959</c:v>
                </c:pt>
                <c:pt idx="1">
                  <c:v>89.728267567634262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1-48BE-420E-B360-C5837D4E3FEA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219"/>
        <c:axId val="522639711"/>
        <c:axId val="449631503"/>
      </c:barChart>
      <c:catAx>
        <c:axId val="522639711"/>
        <c:scaling>
          <c:orientation val="minMax"/>
        </c:scaling>
        <c:delete val="0"/>
        <c:axPos val="b"/>
        <c:numFmt formatCode="General" sourceLinked="1"/>
        <c:majorTickMark val="cross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49631503"/>
        <c:crosses val="autoZero"/>
        <c:auto val="1"/>
        <c:lblAlgn val="ctr"/>
        <c:lblOffset val="100"/>
        <c:noMultiLvlLbl val="0"/>
      </c:catAx>
      <c:valAx>
        <c:axId val="44963150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de-DE" dirty="0"/>
                  <a:t>Oligo-</a:t>
                </a:r>
                <a:r>
                  <a:rPr lang="de-DE" dirty="0" err="1"/>
                  <a:t>saccharide</a:t>
                </a:r>
                <a:r>
                  <a:rPr lang="de-DE" dirty="0"/>
                  <a:t> </a:t>
                </a:r>
                <a:r>
                  <a:rPr lang="de-DE" dirty="0" err="1"/>
                  <a:t>yield</a:t>
                </a:r>
                <a:endParaRPr lang="de-DE" dirty="0"/>
              </a:p>
              <a:p>
                <a:pPr>
                  <a:defRPr/>
                </a:pPr>
                <a:r>
                  <a:rPr lang="de-DE" dirty="0"/>
                  <a:t>(w/w % </a:t>
                </a:r>
                <a:r>
                  <a:rPr lang="de-DE" dirty="0" err="1"/>
                  <a:t>of</a:t>
                </a:r>
                <a:r>
                  <a:rPr lang="de-DE" dirty="0"/>
                  <a:t> initial DM </a:t>
                </a:r>
                <a:r>
                  <a:rPr lang="de-DE" dirty="0" err="1"/>
                  <a:t>sugar</a:t>
                </a:r>
                <a:r>
                  <a:rPr lang="de-DE" dirty="0"/>
                  <a:t>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22639711"/>
        <c:crosses val="autoZero"/>
        <c:crossBetween val="between"/>
        <c:majorUnit val="25"/>
      </c:valAx>
      <c:spPr>
        <a:noFill/>
        <a:ln w="6350">
          <a:solidFill>
            <a:schemeClr val="tx1"/>
          </a:solidFill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290EB14-0930-4862-997B-9CA85A3A040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30C11207-A0B3-4C85-B485-F3D65C88F3F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27370AC-1F69-437B-87D8-21E31D4DFD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46C67-7234-4FE7-813A-FC17F49A50E5}" type="datetimeFigureOut">
              <a:rPr lang="de-DE" smtClean="0"/>
              <a:t>17.12.2020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4AD1B25-CF84-41CA-AC47-DDED317264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84DA7B2-E120-450A-A5C7-7CAFD7ECFB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7ED1C3-BB39-47CB-B778-C1CF4427DB1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037006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8A0DEB8-E47D-4759-8331-81433A75AC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52A6E12D-A006-4F6E-87BB-2A17870546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FCB5412-B60F-414B-BD6A-98A27B6979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46C67-7234-4FE7-813A-FC17F49A50E5}" type="datetimeFigureOut">
              <a:rPr lang="de-DE" smtClean="0"/>
              <a:t>17.12.2020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93AA338-77C2-4355-A582-7FD4F01A7A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D34C8FB-95F0-4315-91B1-2B88327DB0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7ED1C3-BB39-47CB-B778-C1CF4427DB1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862426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76C221B5-9E55-48E1-9D6F-4E582CAAD2D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0DBC3190-9673-44CA-B9FE-1DD780275CA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3BDBBBC-8343-4398-A4CF-0BCB41EBEE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46C67-7234-4FE7-813A-FC17F49A50E5}" type="datetimeFigureOut">
              <a:rPr lang="de-DE" smtClean="0"/>
              <a:t>17.12.2020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4402E8F5-F921-49D6-BDF2-E398516918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4D5F0C4-B594-4C26-9CC9-A6FD032AF4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7ED1C3-BB39-47CB-B778-C1CF4427DB1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943554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F7EC07D-1E36-4977-ADDB-6DC6A2AFFA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E9775605-A74C-4E9B-8391-0EBCE6AEE9A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893DC996-07AD-4F8B-B03A-20EF603ACD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46C67-7234-4FE7-813A-FC17F49A50E5}" type="datetimeFigureOut">
              <a:rPr lang="de-DE" smtClean="0"/>
              <a:t>17.12.2020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54CD2C3-371A-4B48-82BD-F8EE9605B6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07EFC9B-9E6F-4D3F-8EA0-45E42C3DC6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7ED1C3-BB39-47CB-B778-C1CF4427DB1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169630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B2174D5-2E5A-4EDB-8CA4-9D482E13EF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EBDAFA79-F1EC-4E61-9170-024AC941BF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DC5648A-3630-4F8A-B8C4-7E3EE3CFF3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46C67-7234-4FE7-813A-FC17F49A50E5}" type="datetimeFigureOut">
              <a:rPr lang="de-DE" smtClean="0"/>
              <a:t>17.12.2020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69D3340-8ADE-4B3C-AB2A-B6722D2D49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165CDF1-7729-4275-96F7-0BCB86FEF9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7ED1C3-BB39-47CB-B778-C1CF4427DB1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514644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0D75C81-6105-447E-93C2-5208F8E1E0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B2C04969-7CF0-4ED1-870B-31E80F2A52F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4FA1EE22-2F48-4D30-9AF1-30848BDF235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2F5B0382-1627-4A6F-87D2-93F4418403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46C67-7234-4FE7-813A-FC17F49A50E5}" type="datetimeFigureOut">
              <a:rPr lang="de-DE" smtClean="0"/>
              <a:t>17.12.2020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38BA0E91-1393-449C-B89C-8FE2D3B1A4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6B9B23BB-2852-49D3-9671-E0ADCE0786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7ED1C3-BB39-47CB-B778-C1CF4427DB1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234588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54C9121-7E11-4F1C-A97B-689425BA39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23666F8D-F8CA-45AC-940B-E96A905211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815B5DF9-C242-45CE-A90A-0AAF150900B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812B3DB4-4912-4AFD-880A-6A9B0210930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31F79227-0994-4560-BDD3-5FC1A029E2A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3A8EFE6B-C33A-46E4-9194-BA83E89B07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46C67-7234-4FE7-813A-FC17F49A50E5}" type="datetimeFigureOut">
              <a:rPr lang="de-DE" smtClean="0"/>
              <a:t>17.12.2020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E30F5514-70A7-4E0D-8A27-D188991446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EBA4AB15-9C26-40CF-A472-50C21211AE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7ED1C3-BB39-47CB-B778-C1CF4427DB1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022539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CFB0C56-2C08-4C7E-9EC6-FEDA8022DB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D606E898-C315-441A-A5FF-899E0D529B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46C67-7234-4FE7-813A-FC17F49A50E5}" type="datetimeFigureOut">
              <a:rPr lang="de-DE" smtClean="0"/>
              <a:t>17.12.2020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22046B9C-96F0-4674-A276-6EA7BB7EE1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2919AFE2-E1F1-43C4-8535-7FD08BB46C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7ED1C3-BB39-47CB-B778-C1CF4427DB1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106874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3284069A-94B2-4D8E-87F9-91505D4DE7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46C67-7234-4FE7-813A-FC17F49A50E5}" type="datetimeFigureOut">
              <a:rPr lang="de-DE" smtClean="0"/>
              <a:t>17.12.2020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51DEAFDE-0124-4CFF-AB2F-55960DAB0B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B049F13A-5E85-4DB5-8AA3-8CC57BF2BA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7ED1C3-BB39-47CB-B778-C1CF4427DB1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175893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4FE9662-3488-4653-9EA3-2F45969796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7ABEB7F0-EC57-40C7-B0F1-589C2E263CD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ECFE6103-09D9-47AE-B429-924DC1517E7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63756CDA-B5E8-412A-A8FC-0E4C172CA6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46C67-7234-4FE7-813A-FC17F49A50E5}" type="datetimeFigureOut">
              <a:rPr lang="de-DE" smtClean="0"/>
              <a:t>17.12.2020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5B216065-AF0A-4547-BA3B-7475DFA064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B1A48029-7BEB-41BC-ADEA-26C3018D0D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7ED1C3-BB39-47CB-B778-C1CF4427DB1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499044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938677B-8122-4FDB-B134-EC04266321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72AC1B39-E5E9-4CA2-AB09-884B100CE71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C2810BA2-44C7-4F0F-BEE4-94AAAD1150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9CEEBE41-6A39-47B8-8F9A-08022EF739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46C67-7234-4FE7-813A-FC17F49A50E5}" type="datetimeFigureOut">
              <a:rPr lang="de-DE" smtClean="0"/>
              <a:t>17.12.2020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E3AFA79A-6F85-4C48-AD02-BAD08EEFBF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D38D4DE3-05CE-4948-B5A2-1209870482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7ED1C3-BB39-47CB-B778-C1CF4427DB1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351701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5265A26E-4E29-4968-A14D-EFBBCFF2A8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C590F764-C767-4457-A231-8A59F39F13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41B097F-FC4F-4AD5-8514-C2D827EA185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E46C67-7234-4FE7-813A-FC17F49A50E5}" type="datetimeFigureOut">
              <a:rPr lang="de-DE" smtClean="0"/>
              <a:t>17.12.2020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8187E359-DBD8-4852-B5CE-B5577FA7BDA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7997887F-BBE8-4A51-9C43-E6698A772F0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7ED1C3-BB39-47CB-B778-C1CF4427DB1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264552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-2608"/>
            <a:ext cx="12192000" cy="508086"/>
          </a:xfrm>
        </p:spPr>
        <p:txBody>
          <a:bodyPr>
            <a:noAutofit/>
          </a:bodyPr>
          <a:lstStyle/>
          <a:p>
            <a:r>
              <a:rPr lang="en-GB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orting information</a:t>
            </a:r>
          </a:p>
        </p:txBody>
      </p:sp>
      <p:sp>
        <p:nvSpPr>
          <p:cNvPr id="5" name="Subtitle 2">
            <a:extLst>
              <a:ext uri="{FF2B5EF4-FFF2-40B4-BE49-F238E27FC236}">
                <a16:creationId xmlns:a16="http://schemas.microsoft.com/office/drawing/2014/main" id="{5D7A33D5-68E8-4BF7-AA28-2FD222998A08}"/>
              </a:ext>
            </a:extLst>
          </p:cNvPr>
          <p:cNvSpPr txBox="1">
            <a:spLocks/>
          </p:cNvSpPr>
          <p:nvPr/>
        </p:nvSpPr>
        <p:spPr>
          <a:xfrm>
            <a:off x="1879217" y="1065802"/>
            <a:ext cx="8229600" cy="59926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.S1 FTIR spectra of untreated and </a:t>
            </a:r>
            <a:r>
              <a:rPr lang="en-GB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treated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scanthus Mx2779.</a:t>
            </a:r>
            <a:endParaRPr lang="en-GB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92450FBC-8B34-47B7-BB2B-B7331BADF199}"/>
              </a:ext>
            </a:extLst>
          </p:cNvPr>
          <p:cNvGrpSpPr/>
          <p:nvPr/>
        </p:nvGrpSpPr>
        <p:grpSpPr>
          <a:xfrm>
            <a:off x="1879217" y="2021925"/>
            <a:ext cx="8229600" cy="3739325"/>
            <a:chOff x="1611798" y="1409449"/>
            <a:chExt cx="8229600" cy="3739325"/>
          </a:xfrm>
        </p:grpSpPr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89DAD185-F854-424B-AED7-716B9E4CB276}"/>
                </a:ext>
              </a:extLst>
            </p:cNvPr>
            <p:cNvGrpSpPr/>
            <p:nvPr/>
          </p:nvGrpSpPr>
          <p:grpSpPr>
            <a:xfrm>
              <a:off x="1611798" y="1409449"/>
              <a:ext cx="8229600" cy="3739325"/>
              <a:chOff x="189595" y="1702751"/>
              <a:chExt cx="8229600" cy="3739325"/>
            </a:xfrm>
          </p:grpSpPr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65B6D276-82C7-4D01-80F6-C3155FCB759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89595" y="1702751"/>
                <a:ext cx="8229600" cy="373932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cxnSp>
            <p:nvCxnSpPr>
              <p:cNvPr id="12" name="Straight Connector 11">
                <a:extLst>
                  <a:ext uri="{FF2B5EF4-FFF2-40B4-BE49-F238E27FC236}">
                    <a16:creationId xmlns:a16="http://schemas.microsoft.com/office/drawing/2014/main" id="{1DD8361E-8434-4772-A0C4-8A549A76B419}"/>
                  </a:ext>
                </a:extLst>
              </p:cNvPr>
              <p:cNvCxnSpPr/>
              <p:nvPr/>
            </p:nvCxnSpPr>
            <p:spPr>
              <a:xfrm>
                <a:off x="5137116" y="2009812"/>
                <a:ext cx="7909" cy="3178604"/>
              </a:xfrm>
              <a:prstGeom prst="line">
                <a:avLst/>
              </a:prstGeom>
              <a:ln w="9525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C99824B3-48FB-4A07-BD2D-6AF5F709CD20}"/>
                  </a:ext>
                </a:extLst>
              </p:cNvPr>
              <p:cNvSpPr txBox="1"/>
              <p:nvPr/>
            </p:nvSpPr>
            <p:spPr>
              <a:xfrm>
                <a:off x="4870506" y="1702751"/>
                <a:ext cx="54903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34</a:t>
                </a:r>
              </a:p>
            </p:txBody>
          </p:sp>
          <p:cxnSp>
            <p:nvCxnSpPr>
              <p:cNvPr id="14" name="Straight Connector 13">
                <a:extLst>
                  <a:ext uri="{FF2B5EF4-FFF2-40B4-BE49-F238E27FC236}">
                    <a16:creationId xmlns:a16="http://schemas.microsoft.com/office/drawing/2014/main" id="{588540FC-E848-4754-9C98-1B46EDD97234}"/>
                  </a:ext>
                </a:extLst>
              </p:cNvPr>
              <p:cNvCxnSpPr/>
              <p:nvPr/>
            </p:nvCxnSpPr>
            <p:spPr>
              <a:xfrm>
                <a:off x="5862061" y="2581287"/>
                <a:ext cx="0" cy="2603750"/>
              </a:xfrm>
              <a:prstGeom prst="line">
                <a:avLst/>
              </a:prstGeom>
              <a:ln w="9525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6D929F0C-C8F6-487B-9C29-9C97F4FE840C}"/>
                  </a:ext>
                </a:extLst>
              </p:cNvPr>
              <p:cNvSpPr txBox="1"/>
              <p:nvPr/>
            </p:nvSpPr>
            <p:spPr>
              <a:xfrm>
                <a:off x="5648210" y="2288328"/>
                <a:ext cx="43026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97</a:t>
                </a:r>
              </a:p>
            </p:txBody>
          </p:sp>
          <p:cxnSp>
            <p:nvCxnSpPr>
              <p:cNvPr id="16" name="Straight Connector 15">
                <a:extLst>
                  <a:ext uri="{FF2B5EF4-FFF2-40B4-BE49-F238E27FC236}">
                    <a16:creationId xmlns:a16="http://schemas.microsoft.com/office/drawing/2014/main" id="{26B1032F-0DDE-495F-A8AA-664CBD5F1D83}"/>
                  </a:ext>
                </a:extLst>
              </p:cNvPr>
              <p:cNvCxnSpPr/>
              <p:nvPr/>
            </p:nvCxnSpPr>
            <p:spPr>
              <a:xfrm flipH="1">
                <a:off x="4499588" y="2592023"/>
                <a:ext cx="10503" cy="2588508"/>
              </a:xfrm>
              <a:prstGeom prst="line">
                <a:avLst/>
              </a:prstGeom>
              <a:ln w="9525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9DB60BB9-E879-4FCC-8F4A-01F98E523302}"/>
                  </a:ext>
                </a:extLst>
              </p:cNvPr>
              <p:cNvSpPr txBox="1"/>
              <p:nvPr/>
            </p:nvSpPr>
            <p:spPr>
              <a:xfrm>
                <a:off x="4255321" y="2347276"/>
                <a:ext cx="50957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160</a:t>
                </a:r>
              </a:p>
            </p:txBody>
          </p:sp>
          <p:cxnSp>
            <p:nvCxnSpPr>
              <p:cNvPr id="18" name="Straight Connector 17">
                <a:extLst>
                  <a:ext uri="{FF2B5EF4-FFF2-40B4-BE49-F238E27FC236}">
                    <a16:creationId xmlns:a16="http://schemas.microsoft.com/office/drawing/2014/main" id="{B84E7403-3207-4CAF-823A-AC6E4BD8B58E}"/>
                  </a:ext>
                </a:extLst>
              </p:cNvPr>
              <p:cNvCxnSpPr/>
              <p:nvPr/>
            </p:nvCxnSpPr>
            <p:spPr>
              <a:xfrm>
                <a:off x="4109040" y="3036357"/>
                <a:ext cx="1362" cy="2149270"/>
              </a:xfrm>
              <a:prstGeom prst="line">
                <a:avLst/>
              </a:prstGeom>
              <a:ln w="9525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4BB9EECF-FE8A-4072-9C53-F93FC4114640}"/>
                  </a:ext>
                </a:extLst>
              </p:cNvPr>
              <p:cNvSpPr txBox="1"/>
              <p:nvPr/>
            </p:nvSpPr>
            <p:spPr>
              <a:xfrm>
                <a:off x="3856935" y="2790136"/>
                <a:ext cx="50420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38</a:t>
                </a:r>
              </a:p>
            </p:txBody>
          </p:sp>
          <p:cxnSp>
            <p:nvCxnSpPr>
              <p:cNvPr id="20" name="Straight Connector 19">
                <a:extLst>
                  <a:ext uri="{FF2B5EF4-FFF2-40B4-BE49-F238E27FC236}">
                    <a16:creationId xmlns:a16="http://schemas.microsoft.com/office/drawing/2014/main" id="{4DAB2566-7388-4522-848D-0E3C0CEF487F}"/>
                  </a:ext>
                </a:extLst>
              </p:cNvPr>
              <p:cNvCxnSpPr/>
              <p:nvPr/>
            </p:nvCxnSpPr>
            <p:spPr>
              <a:xfrm>
                <a:off x="1553096" y="3239399"/>
                <a:ext cx="0" cy="1954201"/>
              </a:xfrm>
              <a:prstGeom prst="line">
                <a:avLst/>
              </a:prstGeom>
              <a:ln w="9525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1E49CD5F-B205-4DD9-8FC9-D8A6E150A420}"/>
                  </a:ext>
                </a:extLst>
              </p:cNvPr>
              <p:cNvSpPr txBox="1"/>
              <p:nvPr/>
            </p:nvSpPr>
            <p:spPr>
              <a:xfrm>
                <a:off x="1288569" y="3001728"/>
                <a:ext cx="51649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740</a:t>
                </a:r>
              </a:p>
            </p:txBody>
          </p:sp>
          <p:cxnSp>
            <p:nvCxnSpPr>
              <p:cNvPr id="22" name="Straight Connector 21">
                <a:extLst>
                  <a:ext uri="{FF2B5EF4-FFF2-40B4-BE49-F238E27FC236}">
                    <a16:creationId xmlns:a16="http://schemas.microsoft.com/office/drawing/2014/main" id="{4925BB9E-D949-4FF2-A326-DCEE2E32877D}"/>
                  </a:ext>
                </a:extLst>
              </p:cNvPr>
              <p:cNvCxnSpPr/>
              <p:nvPr/>
            </p:nvCxnSpPr>
            <p:spPr>
              <a:xfrm>
                <a:off x="3708034" y="3244803"/>
                <a:ext cx="0" cy="1954201"/>
              </a:xfrm>
              <a:prstGeom prst="line">
                <a:avLst/>
              </a:prstGeom>
              <a:ln w="9525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374B1C93-4787-4B4F-B318-3534E10FC5AD}"/>
                  </a:ext>
                </a:extLst>
              </p:cNvPr>
              <p:cNvSpPr txBox="1"/>
              <p:nvPr/>
            </p:nvSpPr>
            <p:spPr>
              <a:xfrm>
                <a:off x="3469162" y="3001731"/>
                <a:ext cx="48812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20</a:t>
                </a:r>
              </a:p>
            </p:txBody>
          </p:sp>
          <p:cxnSp>
            <p:nvCxnSpPr>
              <p:cNvPr id="24" name="Straight Connector 23">
                <a:extLst>
                  <a:ext uri="{FF2B5EF4-FFF2-40B4-BE49-F238E27FC236}">
                    <a16:creationId xmlns:a16="http://schemas.microsoft.com/office/drawing/2014/main" id="{CEE17A6F-13F1-439D-A0A7-1EA23C325DFA}"/>
                  </a:ext>
                </a:extLst>
              </p:cNvPr>
              <p:cNvCxnSpPr/>
              <p:nvPr/>
            </p:nvCxnSpPr>
            <p:spPr>
              <a:xfrm flipH="1">
                <a:off x="4785557" y="2350407"/>
                <a:ext cx="14795" cy="2869584"/>
              </a:xfrm>
              <a:prstGeom prst="line">
                <a:avLst/>
              </a:prstGeom>
              <a:ln w="9525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09F825F1-79C3-476E-8A76-098D62B8FD6D}"/>
                  </a:ext>
                </a:extLst>
              </p:cNvPr>
              <p:cNvSpPr txBox="1"/>
              <p:nvPr/>
            </p:nvSpPr>
            <p:spPr>
              <a:xfrm>
                <a:off x="4501007" y="2035304"/>
                <a:ext cx="52777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105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70CB3075-5AAD-4B72-ACA2-42EDA8A5E8C7}"/>
                  </a:ext>
                </a:extLst>
              </p:cNvPr>
              <p:cNvSpPr txBox="1"/>
              <p:nvPr/>
            </p:nvSpPr>
            <p:spPr>
              <a:xfrm>
                <a:off x="2480960" y="3001730"/>
                <a:ext cx="50320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08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156BD179-C936-4B69-B3DD-17FC6FEAC369}"/>
                  </a:ext>
                </a:extLst>
              </p:cNvPr>
              <p:cNvSpPr txBox="1"/>
              <p:nvPr/>
            </p:nvSpPr>
            <p:spPr>
              <a:xfrm>
                <a:off x="2912173" y="3003081"/>
                <a:ext cx="52874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423</a:t>
                </a:r>
              </a:p>
            </p:txBody>
          </p:sp>
          <p:cxnSp>
            <p:nvCxnSpPr>
              <p:cNvPr id="28" name="Straight Connector 27">
                <a:extLst>
                  <a:ext uri="{FF2B5EF4-FFF2-40B4-BE49-F238E27FC236}">
                    <a16:creationId xmlns:a16="http://schemas.microsoft.com/office/drawing/2014/main" id="{17F8B716-FCDB-4BCF-966C-7B729BAC1F98}"/>
                  </a:ext>
                </a:extLst>
              </p:cNvPr>
              <p:cNvCxnSpPr/>
              <p:nvPr/>
            </p:nvCxnSpPr>
            <p:spPr>
              <a:xfrm flipH="1">
                <a:off x="2252890" y="3264805"/>
                <a:ext cx="4668" cy="1915565"/>
              </a:xfrm>
              <a:prstGeom prst="line">
                <a:avLst/>
              </a:prstGeom>
              <a:ln w="9525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0D334420-6D8B-40BF-8624-28A2A9F125B1}"/>
                  </a:ext>
                </a:extLst>
              </p:cNvPr>
              <p:cNvSpPr txBox="1"/>
              <p:nvPr/>
            </p:nvSpPr>
            <p:spPr>
              <a:xfrm>
                <a:off x="2009990" y="3001729"/>
                <a:ext cx="50320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600</a:t>
                </a:r>
              </a:p>
            </p:txBody>
          </p:sp>
          <p:cxnSp>
            <p:nvCxnSpPr>
              <p:cNvPr id="30" name="Straight Connector 29">
                <a:extLst>
                  <a:ext uri="{FF2B5EF4-FFF2-40B4-BE49-F238E27FC236}">
                    <a16:creationId xmlns:a16="http://schemas.microsoft.com/office/drawing/2014/main" id="{3C6CE2D0-0F6A-433D-8F98-434A1506D323}"/>
                  </a:ext>
                </a:extLst>
              </p:cNvPr>
              <p:cNvCxnSpPr/>
              <p:nvPr/>
            </p:nvCxnSpPr>
            <p:spPr>
              <a:xfrm flipH="1">
                <a:off x="2724213" y="3292321"/>
                <a:ext cx="4668" cy="1915565"/>
              </a:xfrm>
              <a:prstGeom prst="line">
                <a:avLst/>
              </a:prstGeom>
              <a:ln w="9525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>
                <a:extLst>
                  <a:ext uri="{FF2B5EF4-FFF2-40B4-BE49-F238E27FC236}">
                    <a16:creationId xmlns:a16="http://schemas.microsoft.com/office/drawing/2014/main" id="{8D7E538C-0244-4AA4-986B-4B31A2FCD51F}"/>
                  </a:ext>
                </a:extLst>
              </p:cNvPr>
              <p:cNvCxnSpPr/>
              <p:nvPr/>
            </p:nvCxnSpPr>
            <p:spPr>
              <a:xfrm flipH="1">
                <a:off x="3170138" y="3288253"/>
                <a:ext cx="4668" cy="1915565"/>
              </a:xfrm>
              <a:prstGeom prst="line">
                <a:avLst/>
              </a:prstGeom>
              <a:ln w="9525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A164C31D-3D34-4122-B3D9-5E4AA0CD3DD1}"/>
                </a:ext>
              </a:extLst>
            </p:cNvPr>
            <p:cNvCxnSpPr/>
            <p:nvPr/>
          </p:nvCxnSpPr>
          <p:spPr>
            <a:xfrm flipH="1">
              <a:off x="9817679" y="1413092"/>
              <a:ext cx="6894" cy="3681089"/>
            </a:xfrm>
            <a:prstGeom prst="line">
              <a:avLst/>
            </a:prstGeom>
            <a:ln w="9525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7168507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Subtitle 2">
            <a:extLst>
              <a:ext uri="{FF2B5EF4-FFF2-40B4-BE49-F238E27FC236}">
                <a16:creationId xmlns:a16="http://schemas.microsoft.com/office/drawing/2014/main" id="{381489C0-4756-42A5-94C1-2A04890669B1}"/>
              </a:ext>
            </a:extLst>
          </p:cNvPr>
          <p:cNvSpPr txBox="1">
            <a:spLocks/>
          </p:cNvSpPr>
          <p:nvPr/>
        </p:nvSpPr>
        <p:spPr>
          <a:xfrm>
            <a:off x="2763394" y="1415930"/>
            <a:ext cx="6665212" cy="93674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lnSpc>
                <a:spcPct val="100000"/>
              </a:lnSpc>
              <a:spcBef>
                <a:spcPts val="0"/>
              </a:spcBef>
              <a:buNone/>
            </a:pP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GB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uco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oligosaccharides (GOS) and </a:t>
            </a:r>
            <a:r>
              <a:rPr lang="en-GB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xylo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oligosaccharides (XOS) present in the liquid fraction after steam explosion and [C</a:t>
            </a:r>
            <a:r>
              <a:rPr lang="en-GB" sz="16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m][</a:t>
            </a:r>
            <a:r>
              <a:rPr lang="en-GB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Ac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] pretreatment of </a:t>
            </a:r>
            <a:r>
              <a:rPr lang="en-GB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scanthus Mx2779.</a:t>
            </a:r>
            <a:endParaRPr lang="en-GB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Diagramm 2">
            <a:extLst>
              <a:ext uri="{FF2B5EF4-FFF2-40B4-BE49-F238E27FC236}">
                <a16:creationId xmlns:a16="http://schemas.microsoft.com/office/drawing/2014/main" id="{7CAB1F13-2D3C-497D-9A50-A38E26E434C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85396822"/>
              </p:ext>
            </p:extLst>
          </p:nvPr>
        </p:nvGraphicFramePr>
        <p:xfrm>
          <a:off x="3810000" y="2583873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1245163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627046" y="4421480"/>
            <a:ext cx="10515599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correlation coefficient of -1 indicates a perfect negative correlation. </a:t>
            </a:r>
          </a:p>
          <a:p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 xylan content increases, glucose yields decreases. As xylan content decreases, glucose yields increases.</a:t>
            </a:r>
          </a:p>
          <a:p>
            <a:r>
              <a:rPr lang="en-GB" sz="1000" dirty="0">
                <a:solidFill>
                  <a:srgbClr val="000000"/>
                </a:solidFill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Data are expressed as means ± standard error (n ≥ 3). 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≤ 0.05; **</a:t>
            </a:r>
            <a:r>
              <a:rPr lang="en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≤ 0.01; ***</a:t>
            </a:r>
            <a:r>
              <a:rPr lang="en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≤ 0.001.</a:t>
            </a:r>
          </a:p>
        </p:txBody>
      </p:sp>
      <p:sp>
        <p:nvSpPr>
          <p:cNvPr id="10" name="Rectangle 9"/>
          <p:cNvSpPr/>
          <p:nvPr/>
        </p:nvSpPr>
        <p:spPr>
          <a:xfrm>
            <a:off x="627047" y="6241734"/>
            <a:ext cx="9067236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correlation coefficient of 1 indicates a perfect positive correlation. </a:t>
            </a:r>
          </a:p>
          <a:p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 CLL (lignin with condensed &amp; cross-linked G-lignin subunits) content increases, glucose yields increases.</a:t>
            </a:r>
          </a:p>
          <a:p>
            <a:r>
              <a:rPr lang="en-GB" sz="1000" dirty="0">
                <a:solidFill>
                  <a:srgbClr val="000000"/>
                </a:solidFill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Data are expressed as means ± standard error (n ≥ 3). 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≤ 0.05; **</a:t>
            </a:r>
            <a:r>
              <a:rPr lang="en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≤ 0.01; ***</a:t>
            </a:r>
            <a:r>
              <a:rPr lang="en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≤ 0.001.</a:t>
            </a: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56120072"/>
              </p:ext>
            </p:extLst>
          </p:nvPr>
        </p:nvGraphicFramePr>
        <p:xfrm>
          <a:off x="627047" y="3343183"/>
          <a:ext cx="10515599" cy="1078297"/>
        </p:xfrm>
        <a:graphic>
          <a:graphicData uri="http://schemas.openxmlformats.org/drawingml/2006/table">
            <a:tbl>
              <a:tblPr/>
              <a:tblGrid>
                <a:gridCol w="2446317">
                  <a:extLst>
                    <a:ext uri="{9D8B030D-6E8A-4147-A177-3AD203B41FA5}">
                      <a16:colId xmlns:a16="http://schemas.microsoft.com/office/drawing/2014/main" val="2063251511"/>
                    </a:ext>
                  </a:extLst>
                </a:gridCol>
                <a:gridCol w="2422566">
                  <a:extLst>
                    <a:ext uri="{9D8B030D-6E8A-4147-A177-3AD203B41FA5}">
                      <a16:colId xmlns:a16="http://schemas.microsoft.com/office/drawing/2014/main" val="2574078827"/>
                    </a:ext>
                  </a:extLst>
                </a:gridCol>
                <a:gridCol w="1451758">
                  <a:extLst>
                    <a:ext uri="{9D8B030D-6E8A-4147-A177-3AD203B41FA5}">
                      <a16:colId xmlns:a16="http://schemas.microsoft.com/office/drawing/2014/main" val="3281727972"/>
                    </a:ext>
                  </a:extLst>
                </a:gridCol>
                <a:gridCol w="1380506">
                  <a:extLst>
                    <a:ext uri="{9D8B030D-6E8A-4147-A177-3AD203B41FA5}">
                      <a16:colId xmlns:a16="http://schemas.microsoft.com/office/drawing/2014/main" val="1662847761"/>
                    </a:ext>
                  </a:extLst>
                </a:gridCol>
                <a:gridCol w="1401288">
                  <a:extLst>
                    <a:ext uri="{9D8B030D-6E8A-4147-A177-3AD203B41FA5}">
                      <a16:colId xmlns:a16="http://schemas.microsoft.com/office/drawing/2014/main" val="3861620218"/>
                    </a:ext>
                  </a:extLst>
                </a:gridCol>
                <a:gridCol w="1413164">
                  <a:extLst>
                    <a:ext uri="{9D8B030D-6E8A-4147-A177-3AD203B41FA5}">
                      <a16:colId xmlns:a16="http://schemas.microsoft.com/office/drawing/2014/main" val="778536638"/>
                    </a:ext>
                  </a:extLst>
                </a:gridCol>
              </a:tblGrid>
              <a:tr h="178231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onversion of glucan to glucose (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lucan Content (w/w 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Xylan Content (w/w 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ignin Content (w/w 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etyl Content (w/w 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65688453"/>
                  </a:ext>
                </a:extLst>
              </a:tr>
              <a:tr h="178231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onversion of glucan to glucose (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43406701"/>
                  </a:ext>
                </a:extLst>
              </a:tr>
              <a:tr h="178231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lucan Content (w/w 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0.1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0216154"/>
                  </a:ext>
                </a:extLst>
              </a:tr>
              <a:tr h="178231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Xylan Content (w/w 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0.98***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0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68820756"/>
                  </a:ext>
                </a:extLst>
              </a:tr>
              <a:tr h="178231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ignin Content (w/w 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0.6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4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5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50970806"/>
                  </a:ext>
                </a:extLst>
              </a:tr>
              <a:tr h="187142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etyl Content (w/w 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0.5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0.4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5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4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61831488"/>
                  </a:ext>
                </a:extLst>
              </a:tr>
            </a:tbl>
          </a:graphicData>
        </a:graphic>
      </p:graphicFrame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71579975"/>
              </p:ext>
            </p:extLst>
          </p:nvPr>
        </p:nvGraphicFramePr>
        <p:xfrm>
          <a:off x="627046" y="5279709"/>
          <a:ext cx="9067236" cy="962025"/>
        </p:xfrm>
        <a:graphic>
          <a:graphicData uri="http://schemas.openxmlformats.org/drawingml/2006/table">
            <a:tbl>
              <a:tblPr/>
              <a:tblGrid>
                <a:gridCol w="2506776">
                  <a:extLst>
                    <a:ext uri="{9D8B030D-6E8A-4147-A177-3AD203B41FA5}">
                      <a16:colId xmlns:a16="http://schemas.microsoft.com/office/drawing/2014/main" val="1069558029"/>
                    </a:ext>
                  </a:extLst>
                </a:gridCol>
                <a:gridCol w="2524208">
                  <a:extLst>
                    <a:ext uri="{9D8B030D-6E8A-4147-A177-3AD203B41FA5}">
                      <a16:colId xmlns:a16="http://schemas.microsoft.com/office/drawing/2014/main" val="1889386065"/>
                    </a:ext>
                  </a:extLst>
                </a:gridCol>
                <a:gridCol w="1115672">
                  <a:extLst>
                    <a:ext uri="{9D8B030D-6E8A-4147-A177-3AD203B41FA5}">
                      <a16:colId xmlns:a16="http://schemas.microsoft.com/office/drawing/2014/main" val="1397571552"/>
                    </a:ext>
                  </a:extLst>
                </a:gridCol>
                <a:gridCol w="1462209">
                  <a:extLst>
                    <a:ext uri="{9D8B030D-6E8A-4147-A177-3AD203B41FA5}">
                      <a16:colId xmlns:a16="http://schemas.microsoft.com/office/drawing/2014/main" val="3220542133"/>
                    </a:ext>
                  </a:extLst>
                </a:gridCol>
                <a:gridCol w="1458371">
                  <a:extLst>
                    <a:ext uri="{9D8B030D-6E8A-4147-A177-3AD203B41FA5}">
                      <a16:colId xmlns:a16="http://schemas.microsoft.com/office/drawing/2014/main" val="1875621157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onversion of glucan to glucose (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OI (A1423/A897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BI (A3400/A1320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LL (A1508/A1600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3695101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onversion of glucan to glucose (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3029999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OI (A1423/A897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0.0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4189531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BI (A3400/A1320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4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0.2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3637009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LL (A1508/A1600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92***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1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3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5059716"/>
                  </a:ext>
                </a:extLst>
              </a:tr>
            </a:tbl>
          </a:graphicData>
        </a:graphic>
      </p:graphicFrame>
      <p:sp>
        <p:nvSpPr>
          <p:cNvPr id="8" name="Rectangle 7"/>
          <p:cNvSpPr/>
          <p:nvPr/>
        </p:nvSpPr>
        <p:spPr>
          <a:xfrm>
            <a:off x="860265" y="2484954"/>
            <a:ext cx="10515599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correlation coefficient of -1 indicates a perfect negative correlation. . </a:t>
            </a:r>
          </a:p>
          <a:p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 xylan content decreases, CLL increases. As xylan content increases, CLL decreases.</a:t>
            </a:r>
          </a:p>
          <a:p>
            <a:r>
              <a:rPr lang="en-GB" sz="1000" dirty="0">
                <a:solidFill>
                  <a:srgbClr val="000000"/>
                </a:solidFill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Data are expressed as means ± standard error (n ≥ 3). 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≤ 0.05; **</a:t>
            </a:r>
            <a:r>
              <a:rPr lang="en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≤ 0.01; ***</a:t>
            </a:r>
            <a:r>
              <a:rPr lang="en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≤ 0.001.</a:t>
            </a:r>
          </a:p>
        </p:txBody>
      </p:sp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01601555"/>
              </p:ext>
            </p:extLst>
          </p:nvPr>
        </p:nvGraphicFramePr>
        <p:xfrm>
          <a:off x="627046" y="1097278"/>
          <a:ext cx="10982036" cy="1352550"/>
        </p:xfrm>
        <a:graphic>
          <a:graphicData uri="http://schemas.openxmlformats.org/drawingml/2006/table">
            <a:tbl>
              <a:tblPr/>
              <a:tblGrid>
                <a:gridCol w="1995055">
                  <a:extLst>
                    <a:ext uri="{9D8B030D-6E8A-4147-A177-3AD203B41FA5}">
                      <a16:colId xmlns:a16="http://schemas.microsoft.com/office/drawing/2014/main" val="2350583229"/>
                    </a:ext>
                  </a:extLst>
                </a:gridCol>
                <a:gridCol w="2078181">
                  <a:extLst>
                    <a:ext uri="{9D8B030D-6E8A-4147-A177-3AD203B41FA5}">
                      <a16:colId xmlns:a16="http://schemas.microsoft.com/office/drawing/2014/main" val="4113421129"/>
                    </a:ext>
                  </a:extLst>
                </a:gridCol>
                <a:gridCol w="1505528">
                  <a:extLst>
                    <a:ext uri="{9D8B030D-6E8A-4147-A177-3AD203B41FA5}">
                      <a16:colId xmlns:a16="http://schemas.microsoft.com/office/drawing/2014/main" val="2650103935"/>
                    </a:ext>
                  </a:extLst>
                </a:gridCol>
                <a:gridCol w="1597891">
                  <a:extLst>
                    <a:ext uri="{9D8B030D-6E8A-4147-A177-3AD203B41FA5}">
                      <a16:colId xmlns:a16="http://schemas.microsoft.com/office/drawing/2014/main" val="3262947301"/>
                    </a:ext>
                  </a:extLst>
                </a:gridCol>
                <a:gridCol w="1219200">
                  <a:extLst>
                    <a:ext uri="{9D8B030D-6E8A-4147-A177-3AD203B41FA5}">
                      <a16:colId xmlns:a16="http://schemas.microsoft.com/office/drawing/2014/main" val="1877338041"/>
                    </a:ext>
                  </a:extLst>
                </a:gridCol>
                <a:gridCol w="1191491">
                  <a:extLst>
                    <a:ext uri="{9D8B030D-6E8A-4147-A177-3AD203B41FA5}">
                      <a16:colId xmlns:a16="http://schemas.microsoft.com/office/drawing/2014/main" val="3325610655"/>
                    </a:ext>
                  </a:extLst>
                </a:gridCol>
                <a:gridCol w="1394690">
                  <a:extLst>
                    <a:ext uri="{9D8B030D-6E8A-4147-A177-3AD203B41FA5}">
                      <a16:colId xmlns:a16="http://schemas.microsoft.com/office/drawing/2014/main" val="460876134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onversion of glucan to GOS (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Xylan Content (w/w 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ignin Content (w/w 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OI (A1423/A897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BI (A3400/A1320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LL (A1508/A1600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0396441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onversion of glucan to GOS (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550882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Xylan Content (w/w 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0.6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3475137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ignin Content (w/w 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0.5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5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273281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OI (A1423/A897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1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0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0.0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62602398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BI (A3400/A1320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6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0.3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0.7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0.3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78772709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LL (A1508/A1600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7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0.97*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0.5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0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3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15453836"/>
                  </a:ext>
                </a:extLst>
              </a:tr>
            </a:tbl>
          </a:graphicData>
        </a:graphic>
      </p:graphicFrame>
      <p:sp>
        <p:nvSpPr>
          <p:cNvPr id="9" name="Subtitle 2"/>
          <p:cNvSpPr txBox="1">
            <a:spLocks/>
          </p:cNvSpPr>
          <p:nvPr/>
        </p:nvSpPr>
        <p:spPr>
          <a:xfrm>
            <a:off x="1" y="128286"/>
            <a:ext cx="12192000" cy="59926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1. Correlation between biomass properties and 72 hr glucan hydrolysis yields for untreated and </a:t>
            </a:r>
            <a:r>
              <a:rPr lang="en-GB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treated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scanthus Mx2779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213334760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ubtitle 2">
            <a:extLst>
              <a:ext uri="{FF2B5EF4-FFF2-40B4-BE49-F238E27FC236}">
                <a16:creationId xmlns:a16="http://schemas.microsoft.com/office/drawing/2014/main" id="{A2CA9AF4-A4D6-403F-95B1-6C48B6D518F7}"/>
              </a:ext>
            </a:extLst>
          </p:cNvPr>
          <p:cNvSpPr txBox="1">
            <a:spLocks/>
          </p:cNvSpPr>
          <p:nvPr/>
        </p:nvSpPr>
        <p:spPr>
          <a:xfrm>
            <a:off x="1026825" y="128286"/>
            <a:ext cx="9894217" cy="59926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2. Chemical reactions and conversions during pretreatment, enzymatic hydrolysis, fermentation and CHP steps.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9EF93408-8841-49FA-9FF8-CFC0A5064CA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63447679"/>
              </p:ext>
            </p:extLst>
          </p:nvPr>
        </p:nvGraphicFramePr>
        <p:xfrm>
          <a:off x="1026826" y="803062"/>
          <a:ext cx="9462996" cy="5110336"/>
        </p:xfrm>
        <a:graphic>
          <a:graphicData uri="http://schemas.openxmlformats.org/drawingml/2006/table">
            <a:tbl>
              <a:tblPr/>
              <a:tblGrid>
                <a:gridCol w="4368660">
                  <a:extLst>
                    <a:ext uri="{9D8B030D-6E8A-4147-A177-3AD203B41FA5}">
                      <a16:colId xmlns:a16="http://schemas.microsoft.com/office/drawing/2014/main" val="737861500"/>
                    </a:ext>
                  </a:extLst>
                </a:gridCol>
                <a:gridCol w="579891">
                  <a:extLst>
                    <a:ext uri="{9D8B030D-6E8A-4147-A177-3AD203B41FA5}">
                      <a16:colId xmlns:a16="http://schemas.microsoft.com/office/drawing/2014/main" val="2991043755"/>
                    </a:ext>
                  </a:extLst>
                </a:gridCol>
                <a:gridCol w="1002525">
                  <a:extLst>
                    <a:ext uri="{9D8B030D-6E8A-4147-A177-3AD203B41FA5}">
                      <a16:colId xmlns:a16="http://schemas.microsoft.com/office/drawing/2014/main" val="4194165760"/>
                    </a:ext>
                  </a:extLst>
                </a:gridCol>
                <a:gridCol w="1218757">
                  <a:extLst>
                    <a:ext uri="{9D8B030D-6E8A-4147-A177-3AD203B41FA5}">
                      <a16:colId xmlns:a16="http://schemas.microsoft.com/office/drawing/2014/main" val="540936449"/>
                    </a:ext>
                  </a:extLst>
                </a:gridCol>
                <a:gridCol w="897489">
                  <a:extLst>
                    <a:ext uri="{9D8B030D-6E8A-4147-A177-3AD203B41FA5}">
                      <a16:colId xmlns:a16="http://schemas.microsoft.com/office/drawing/2014/main" val="1600483016"/>
                    </a:ext>
                  </a:extLst>
                </a:gridCol>
                <a:gridCol w="1395674">
                  <a:extLst>
                    <a:ext uri="{9D8B030D-6E8A-4147-A177-3AD203B41FA5}">
                      <a16:colId xmlns:a16="http://schemas.microsoft.com/office/drawing/2014/main" val="3391829418"/>
                    </a:ext>
                  </a:extLst>
                </a:gridCol>
              </a:tblGrid>
              <a:tr h="20070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1" i="0" u="sng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5"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version (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19546460"/>
                  </a:ext>
                </a:extLst>
              </a:tr>
              <a:tr h="20070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action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TEA][HSO</a:t>
                      </a:r>
                      <a:r>
                        <a:rPr lang="en-GB" sz="1000" b="1" i="0" u="none" strike="noStrike" baseline="-25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]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 + [TEA][HSO</a:t>
                      </a:r>
                      <a:r>
                        <a:rPr lang="en-GB" sz="1000" b="1" i="0" u="none" strike="noStrike" baseline="-25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]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C</a:t>
                      </a:r>
                      <a:r>
                        <a:rPr lang="en-GB" sz="1000" b="1" i="0" u="none" strike="noStrike" baseline="-25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m][OAc]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 + [C</a:t>
                      </a:r>
                      <a:r>
                        <a:rPr lang="en-GB" sz="1000" b="1" i="0" u="none" strike="noStrike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m][</a:t>
                      </a:r>
                      <a:r>
                        <a:rPr lang="en-GB" sz="1000" b="1" i="0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Ac</a:t>
                      </a:r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]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53839754"/>
                  </a:ext>
                </a:extLst>
              </a:tr>
              <a:tr h="185269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ucan (recovered in </a:t>
                      </a:r>
                      <a:r>
                        <a:rPr lang="en-GB" sz="10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treated</a:t>
                      </a:r>
                      <a:r>
                        <a:rPr lang="en-GB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olids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8%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5%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%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6%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1%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69226083"/>
                  </a:ext>
                </a:extLst>
              </a:tr>
              <a:tr h="185269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ucan → </a:t>
                      </a:r>
                      <a:r>
                        <a:rPr lang="en-GB" sz="10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uco</a:t>
                      </a:r>
                      <a:r>
                        <a:rPr lang="en-GB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oligosaccharides (GOS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%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.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.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%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l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91493474"/>
                  </a:ext>
                </a:extLst>
              </a:tr>
              <a:tr h="20070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ucan + H</a:t>
                      </a:r>
                      <a:r>
                        <a:rPr lang="en-GB" sz="1000" b="0" i="0" u="none" strike="noStrike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GB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 → glucose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l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.d</a:t>
                      </a:r>
                      <a:endParaRPr lang="en-GB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.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dl</a:t>
                      </a:r>
                      <a:endParaRPr lang="en-GB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l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18457311"/>
                  </a:ext>
                </a:extLst>
              </a:tr>
              <a:tr h="185269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ylan (recovered in </a:t>
                      </a:r>
                      <a:r>
                        <a:rPr lang="en-GB" sz="10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treated</a:t>
                      </a:r>
                      <a:r>
                        <a:rPr lang="en-GB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olids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%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%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%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%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%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79108251"/>
                  </a:ext>
                </a:extLst>
              </a:tr>
              <a:tr h="185269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ylan → xylo-oligosaccharides (XOS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2%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.d</a:t>
                      </a:r>
                      <a:endParaRPr lang="en-GB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.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8%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7%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07151359"/>
                  </a:ext>
                </a:extLst>
              </a:tr>
              <a:tr h="20070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ylan + H</a:t>
                      </a:r>
                      <a:r>
                        <a:rPr lang="en-GB" sz="1000" b="0" i="0" u="none" strike="noStrike" baseline="-25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GB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 → xylose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%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.d</a:t>
                      </a:r>
                      <a:endParaRPr lang="en-GB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.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l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dl</a:t>
                      </a:r>
                      <a:endParaRPr lang="en-GB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40379381"/>
                  </a:ext>
                </a:extLst>
              </a:tr>
              <a:tr h="185269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ignin → insoluble lignin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6%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%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%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%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%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67748334"/>
                  </a:ext>
                </a:extLst>
              </a:tr>
              <a:tr h="185269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ignin → soluble lignin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%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4%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9%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4%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7%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51032989"/>
                  </a:ext>
                </a:extLst>
              </a:tr>
              <a:tr h="185269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etyl → acetic aci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%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%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%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%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%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58559825"/>
                  </a:ext>
                </a:extLst>
              </a:tr>
              <a:tr h="185269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zymatic hydrolysis (72 hr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91595304"/>
                  </a:ext>
                </a:extLst>
              </a:tr>
              <a:tr h="185269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ucan → glucose (conversion factor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22814731"/>
                  </a:ext>
                </a:extLst>
              </a:tr>
              <a:tr h="185269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ylan → xylose (conversion factor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24777840"/>
                  </a:ext>
                </a:extLst>
              </a:tr>
              <a:tr h="20070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ucan + H</a:t>
                      </a:r>
                      <a:r>
                        <a:rPr lang="en-GB" sz="1000" b="0" i="0" u="none" strike="noStrike" baseline="-25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GB" sz="1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 → glucose (hydrolysis efficiency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%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5%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9%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%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4%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39489735"/>
                  </a:ext>
                </a:extLst>
              </a:tr>
              <a:tr h="20070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ylan + H</a:t>
                      </a:r>
                      <a:r>
                        <a:rPr lang="en-GB" sz="1000" b="0" i="0" u="none" strike="noStrike" baseline="-25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GB" sz="1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 → xylose (hydrolysis efficiency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3%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5%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%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%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9%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83780175"/>
                  </a:ext>
                </a:extLst>
              </a:tr>
              <a:tr h="185269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rmentation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81084266"/>
                  </a:ext>
                </a:extLst>
              </a:tr>
              <a:tr h="185269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ucose → EtOH (conversion factor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1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50121339"/>
                  </a:ext>
                </a:extLst>
              </a:tr>
              <a:tr h="20070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ucose → CO</a:t>
                      </a:r>
                      <a:r>
                        <a:rPr lang="en-GB" sz="1000" b="0" i="0" u="none" strike="noStrike" baseline="-25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GB" sz="1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conversion factor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8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51037532"/>
                  </a:ext>
                </a:extLst>
              </a:tr>
              <a:tr h="185269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ucose (fermentation efficiency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%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65950168"/>
                  </a:ext>
                </a:extLst>
              </a:tr>
              <a:tr h="185269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ylose (fermentation efficiency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%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68654056"/>
                  </a:ext>
                </a:extLst>
              </a:tr>
              <a:tr h="185269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tOH (Density kg/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8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57190481"/>
                  </a:ext>
                </a:extLst>
              </a:tr>
              <a:tr h="185269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tOH (Recovery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.8%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72387290"/>
                  </a:ext>
                </a:extLst>
              </a:tr>
              <a:tr h="185269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P (combined heat and power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59547792"/>
                  </a:ext>
                </a:extLst>
              </a:tr>
              <a:tr h="185269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er heating value of lignin post pretreatment and enzymatic hydrolysis (GJ/tonne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7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32147064"/>
                  </a:ext>
                </a:extLst>
              </a:tr>
              <a:tr h="185269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P (efficiency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%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53246260"/>
                  </a:ext>
                </a:extLst>
              </a:tr>
              <a:tr h="185269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GJ (in kWh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66658158"/>
                  </a:ext>
                </a:extLst>
              </a:tr>
            </a:tbl>
          </a:graphicData>
        </a:graphic>
      </p:graphicFrame>
      <p:sp>
        <p:nvSpPr>
          <p:cNvPr id="4" name="Subtitle 2">
            <a:extLst>
              <a:ext uri="{FF2B5EF4-FFF2-40B4-BE49-F238E27FC236}">
                <a16:creationId xmlns:a16="http://schemas.microsoft.com/office/drawing/2014/main" id="{CCFEF4FA-E520-4FBB-AFD1-2D0C04E48A13}"/>
              </a:ext>
            </a:extLst>
          </p:cNvPr>
          <p:cNvSpPr txBox="1">
            <a:spLocks/>
          </p:cNvSpPr>
          <p:nvPr/>
        </p:nvSpPr>
        <p:spPr>
          <a:xfrm>
            <a:off x="1026826" y="6130454"/>
            <a:ext cx="5549900" cy="59926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.d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not determined.</a:t>
            </a:r>
          </a:p>
          <a:p>
            <a:pPr marL="0" indent="0">
              <a:buNone/>
            </a:pPr>
            <a:r>
              <a:rPr lang="en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dl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below detection limit.</a:t>
            </a:r>
          </a:p>
        </p:txBody>
      </p:sp>
    </p:spTree>
    <p:extLst>
      <p:ext uri="{BB962C8B-B14F-4D97-AF65-F5344CB8AC3E}">
        <p14:creationId xmlns:p14="http://schemas.microsoft.com/office/powerpoint/2010/main" val="18246703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22</Words>
  <Application>Microsoft Office PowerPoint</Application>
  <PresentationFormat>Widescreen</PresentationFormat>
  <Paragraphs>265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</vt:lpstr>
      <vt:lpstr>Supporting inform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orting information</dc:title>
  <dc:creator>Rakesh Bhatia</dc:creator>
  <cp:lastModifiedBy>Rakesh Bhatia</cp:lastModifiedBy>
  <cp:revision>111</cp:revision>
  <dcterms:created xsi:type="dcterms:W3CDTF">2020-05-14T19:02:51Z</dcterms:created>
  <dcterms:modified xsi:type="dcterms:W3CDTF">2020-12-17T12:22:02Z</dcterms:modified>
</cp:coreProperties>
</file>